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7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49ED2"/>
    <a:srgbClr val="1A479E"/>
    <a:srgbClr val="FC8D59"/>
    <a:srgbClr val="91BFDB"/>
    <a:srgbClr val="F8766D"/>
    <a:srgbClr val="5ADDFE"/>
    <a:srgbClr val="56C5D4"/>
    <a:srgbClr val="EEEE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711" autoAdjust="0"/>
  </p:normalViewPr>
  <p:slideViewPr>
    <p:cSldViewPr snapToGrid="0">
      <p:cViewPr>
        <p:scale>
          <a:sx n="170" d="100"/>
          <a:sy n="170" d="100"/>
        </p:scale>
        <p:origin x="1128" y="-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F1877C-87EF-46DC-99F9-8F6F7C731258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210EEB-8E35-448A-970E-9E5DD1DA72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8112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9496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066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774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4041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0322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7746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3454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0752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4720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3566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0796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195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DE0831-E557-BD9D-57E8-B320ED13ACD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346D04B-0F05-8D4D-B0C4-4CA64AB11784}"/>
              </a:ext>
            </a:extLst>
          </p:cNvPr>
          <p:cNvSpPr txBox="1"/>
          <p:nvPr/>
        </p:nvSpPr>
        <p:spPr>
          <a:xfrm>
            <a:off x="3169456" y="100512"/>
            <a:ext cx="355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AFA358DE-FDE7-3C6C-7EB6-5E1E43BB02A0}"/>
              </a:ext>
            </a:extLst>
          </p:cNvPr>
          <p:cNvSpPr txBox="1"/>
          <p:nvPr/>
        </p:nvSpPr>
        <p:spPr>
          <a:xfrm>
            <a:off x="309990" y="3011319"/>
            <a:ext cx="616701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 | 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OPLS-DA score plot.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eparation between M116 (blue) and the younger cohort (n=4)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yP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red) based on proteomic features. Each point represents a replicate, and ellipses denote the 95% confidence interval for each group. The plot shows strong discrimination (R²Y = 1.00) and excellent predictive performance (Q²Y = 0.993). The predictive component (T1) explained 44% of the variation, with total variance captured at 50.1% (R²X = 0.501). The low RMSEE (0.008) supports the model's robustness.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2674639-8FC6-46C5-F39A-FAEE78203EA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1406" y="522148"/>
            <a:ext cx="2897901" cy="2278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25198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542</TotalTime>
  <Words>110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loy Santos</dc:creator>
  <cp:lastModifiedBy>Eloy Santos</cp:lastModifiedBy>
  <cp:revision>331</cp:revision>
  <cp:lastPrinted>2024-12-23T09:31:56Z</cp:lastPrinted>
  <dcterms:created xsi:type="dcterms:W3CDTF">2024-03-13T15:19:51Z</dcterms:created>
  <dcterms:modified xsi:type="dcterms:W3CDTF">2025-02-17T15:01:22Z</dcterms:modified>
</cp:coreProperties>
</file>